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414" r:id="rId2"/>
    <p:sldId id="415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532CE3A-62D3-B926-119B-2168D202314A}" name="Guarnerio,Jlenia" initials="" userId="S::JGuarnerio@mdanderson.org::dfb0fcd7-5eeb-4e07-a3e8-0dbf46734738" providerId="AD"/>
  <p188:author id="{FD3A1B70-C47D-2978-6E35-9644E6951293}" name="Fowler,Annaliese C" initials="AF" userId="S::ACFowler@mdanderson.org::f91aa872-49e4-4bbc-881e-a32f85655ddd" providerId="AD"/>
  <p188:author id="{C75D9BB2-3030-0BEA-2014-5164B48CAF98}" name="Ko,Emily Y" initials="EK" userId="S::EYKo@mdanderson.org::e85af6e4-4179-4a49-9099-726ab25fb60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B75"/>
    <a:srgbClr val="EFEDE0"/>
    <a:srgbClr val="D0F4DD"/>
    <a:srgbClr val="B5EBAF"/>
    <a:srgbClr val="FEEE8F"/>
    <a:srgbClr val="A3F4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E12A308-F857-D049-AB7B-00D98DFDB9DA}" v="2" dt="2025-11-07T15:16:29.30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67"/>
    <p:restoredTop sz="96098"/>
  </p:normalViewPr>
  <p:slideViewPr>
    <p:cSldViewPr snapToGrid="0">
      <p:cViewPr varScale="1">
        <p:scale>
          <a:sx n="86" d="100"/>
          <a:sy n="86" d="100"/>
        </p:scale>
        <p:origin x="292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microsoft.com/office/2018/10/relationships/authors" Target="author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uarnerio,Jlenia" userId="dfb0fcd7-5eeb-4e07-a3e8-0dbf46734738" providerId="ADAL" clId="{6BCDEB6B-0311-5B2F-9DCA-D1F02FE497D1}"/>
    <pc:docChg chg="custSel addSld modSld">
      <pc:chgData name="Guarnerio,Jlenia" userId="dfb0fcd7-5eeb-4e07-a3e8-0dbf46734738" providerId="ADAL" clId="{6BCDEB6B-0311-5B2F-9DCA-D1F02FE497D1}" dt="2025-11-07T15:16:29.305" v="4"/>
      <pc:docMkLst>
        <pc:docMk/>
      </pc:docMkLst>
      <pc:sldChg chg="addSp delSp modSp new mod">
        <pc:chgData name="Guarnerio,Jlenia" userId="dfb0fcd7-5eeb-4e07-a3e8-0dbf46734738" providerId="ADAL" clId="{6BCDEB6B-0311-5B2F-9DCA-D1F02FE497D1}" dt="2025-11-07T15:16:29.305" v="4"/>
        <pc:sldMkLst>
          <pc:docMk/>
          <pc:sldMk cId="2129089179" sldId="415"/>
        </pc:sldMkLst>
        <pc:spChg chg="del">
          <ac:chgData name="Guarnerio,Jlenia" userId="dfb0fcd7-5eeb-4e07-a3e8-0dbf46734738" providerId="ADAL" clId="{6BCDEB6B-0311-5B2F-9DCA-D1F02FE497D1}" dt="2025-11-07T15:16:11.818" v="1" actId="478"/>
          <ac:spMkLst>
            <pc:docMk/>
            <pc:sldMk cId="2129089179" sldId="415"/>
            <ac:spMk id="2" creationId="{AEB9BC16-43CB-CCD5-FFB0-5C3E36A174FD}"/>
          </ac:spMkLst>
        </pc:spChg>
        <pc:spChg chg="del">
          <ac:chgData name="Guarnerio,Jlenia" userId="dfb0fcd7-5eeb-4e07-a3e8-0dbf46734738" providerId="ADAL" clId="{6BCDEB6B-0311-5B2F-9DCA-D1F02FE497D1}" dt="2025-11-07T15:16:11.818" v="1" actId="478"/>
          <ac:spMkLst>
            <pc:docMk/>
            <pc:sldMk cId="2129089179" sldId="415"/>
            <ac:spMk id="3" creationId="{9B82FD44-0331-A1EA-E29F-2AA149FC00ED}"/>
          </ac:spMkLst>
        </pc:spChg>
        <pc:spChg chg="add mod">
          <ac:chgData name="Guarnerio,Jlenia" userId="dfb0fcd7-5eeb-4e07-a3e8-0dbf46734738" providerId="ADAL" clId="{6BCDEB6B-0311-5B2F-9DCA-D1F02FE497D1}" dt="2025-11-07T15:16:29.305" v="4"/>
          <ac:spMkLst>
            <pc:docMk/>
            <pc:sldMk cId="2129089179" sldId="415"/>
            <ac:spMk id="4" creationId="{EA9BB775-68A9-9339-F0C3-AC948DEA3D68}"/>
          </ac:spMkLst>
        </pc:spChg>
      </pc:sldChg>
    </pc:docChg>
  </pc:docChgLst>
  <pc:docChgLst>
    <pc:chgData name="Guarnerio,Jlenia" userId="dfb0fcd7-5eeb-4e07-a3e8-0dbf46734738" providerId="ADAL" clId="{9FD58F3F-BFD8-5C05-9AE2-EBA86E84DD77}"/>
    <pc:docChg chg="custSel addSld delSld modSld">
      <pc:chgData name="Guarnerio,Jlenia" userId="dfb0fcd7-5eeb-4e07-a3e8-0dbf46734738" providerId="ADAL" clId="{9FD58F3F-BFD8-5C05-9AE2-EBA86E84DD77}" dt="2025-11-05T19:14:23.621" v="76" actId="2696"/>
      <pc:docMkLst>
        <pc:docMk/>
      </pc:docMkLst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23EC13-60F4-8940-B473-63C174F810F9}" type="datetimeFigureOut">
              <a:rPr lang="en-US" smtClean="0"/>
              <a:t>11/7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EDABD9-EFC5-244F-8ED7-0D96910706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8757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EDABD9-EFC5-244F-8ED7-0D969107068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1629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4191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11583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96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512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372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121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8912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091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9619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135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198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794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DF26D86-070C-C48A-0F4F-7C501DBA33F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F42EC0E-3BFB-A324-D9F9-20C05432E602}"/>
              </a:ext>
            </a:extLst>
          </p:cNvPr>
          <p:cNvSpPr txBox="1"/>
          <p:nvPr/>
        </p:nvSpPr>
        <p:spPr>
          <a:xfrm>
            <a:off x="77771" y="0"/>
            <a:ext cx="67024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>
                <a:latin typeface="Helvetica" pitchFamily="2" charset="0"/>
              </a:rPr>
              <a:t>Figure S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68611D9-4FE0-495E-55BD-9AE0F00A3553}"/>
              </a:ext>
            </a:extLst>
          </p:cNvPr>
          <p:cNvSpPr txBox="1"/>
          <p:nvPr/>
        </p:nvSpPr>
        <p:spPr>
          <a:xfrm>
            <a:off x="95996" y="251738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Helvetica" pitchFamily="2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035B173-EEAE-CDB1-5EFC-CE9986F4ACCC}"/>
              </a:ext>
            </a:extLst>
          </p:cNvPr>
          <p:cNvSpPr txBox="1"/>
          <p:nvPr/>
        </p:nvSpPr>
        <p:spPr>
          <a:xfrm>
            <a:off x="95996" y="2554341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Helvetica" pitchFamily="2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A019621-67A3-A31C-293B-FD60B19C3A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6457" y="2806171"/>
            <a:ext cx="2652998" cy="228338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B3A00F6-544D-0F60-AB3B-082CF0703C2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6858000" cy="3429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62C8275-7D06-E1FC-9A87-00EF94B29438}"/>
              </a:ext>
            </a:extLst>
          </p:cNvPr>
          <p:cNvSpPr txBox="1"/>
          <p:nvPr/>
        </p:nvSpPr>
        <p:spPr>
          <a:xfrm>
            <a:off x="95996" y="522377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Helvetica" pitchFamily="2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7F305B4-2CCE-FE9C-A0EB-C5E2D80C1604}"/>
              </a:ext>
            </a:extLst>
          </p:cNvPr>
          <p:cNvSpPr txBox="1"/>
          <p:nvPr/>
        </p:nvSpPr>
        <p:spPr>
          <a:xfrm>
            <a:off x="1379235" y="522377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91073AAF-19F3-2FE7-4FAF-D96482174C5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6577" y="5270348"/>
            <a:ext cx="1131474" cy="225604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27456F29-5C0F-FE23-21CC-D3508FACA54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82956" y="5322308"/>
            <a:ext cx="1083179" cy="2200854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0955874A-C36B-4E9E-8304-CABD5DFF116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666135" y="5322308"/>
            <a:ext cx="1090078" cy="220085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B901D01-AC34-3487-8ECB-70B58F10547B}"/>
              </a:ext>
            </a:extLst>
          </p:cNvPr>
          <p:cNvSpPr txBox="1"/>
          <p:nvPr/>
        </p:nvSpPr>
        <p:spPr>
          <a:xfrm>
            <a:off x="4282689" y="522377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CBE56A70-F9F6-A676-10F7-E5707D2ED42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532049" y="5361853"/>
            <a:ext cx="1172860" cy="21613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29529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A9BB775-68A9-9339-F0C3-AC948DEA3D68}"/>
              </a:ext>
            </a:extLst>
          </p:cNvPr>
          <p:cNvSpPr txBox="1"/>
          <p:nvPr/>
        </p:nvSpPr>
        <p:spPr>
          <a:xfrm>
            <a:off x="329784" y="659567"/>
            <a:ext cx="6220918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S3.</a:t>
            </a:r>
            <a:r>
              <a:rPr lang="en-US" dirty="0"/>
              <a:t> </a:t>
            </a:r>
            <a:r>
              <a:rPr lang="en-US" i="1" dirty="0" err="1"/>
              <a:t>Postn</a:t>
            </a:r>
            <a:r>
              <a:rPr lang="en-US" dirty="0"/>
              <a:t> silencing shapes the immune sarcoma microenvironment. (</a:t>
            </a:r>
            <a:r>
              <a:rPr lang="en-US" b="1" dirty="0"/>
              <a:t>A</a:t>
            </a:r>
            <a:r>
              <a:rPr lang="en-US" dirty="0"/>
              <a:t>) Top marker genes of each subcluster identified in Figure 3B. (</a:t>
            </a:r>
            <a:r>
              <a:rPr lang="en-US" b="1" dirty="0"/>
              <a:t>B</a:t>
            </a:r>
            <a:r>
              <a:rPr lang="en-US" dirty="0"/>
              <a:t>) Comparison of monocyte, macrophage, and dendritic cell proportions in </a:t>
            </a:r>
            <a:r>
              <a:rPr lang="en-US" dirty="0" err="1"/>
              <a:t>shPostn</a:t>
            </a:r>
            <a:r>
              <a:rPr lang="en-US" dirty="0"/>
              <a:t> and </a:t>
            </a:r>
            <a:r>
              <a:rPr lang="en-US" dirty="0" err="1"/>
              <a:t>shSCR</a:t>
            </a:r>
            <a:r>
              <a:rPr lang="en-US" dirty="0"/>
              <a:t> tumors. Experiments were performed in p53</a:t>
            </a:r>
            <a:r>
              <a:rPr lang="en-US" baseline="30000" dirty="0"/>
              <a:t>KO</a:t>
            </a:r>
            <a:r>
              <a:rPr lang="en-US" dirty="0"/>
              <a:t>Vgll3</a:t>
            </a:r>
            <a:r>
              <a:rPr lang="en-US" baseline="30000" dirty="0"/>
              <a:t>OE</a:t>
            </a:r>
            <a:r>
              <a:rPr lang="en-US" dirty="0"/>
              <a:t> model. (</a:t>
            </a:r>
            <a:r>
              <a:rPr lang="en-US" b="1" dirty="0"/>
              <a:t>C</a:t>
            </a:r>
            <a:r>
              <a:rPr lang="en-US" dirty="0"/>
              <a:t>) Weight of tumors generated with p53</a:t>
            </a:r>
            <a:r>
              <a:rPr lang="en-US" baseline="30000" dirty="0"/>
              <a:t>KO</a:t>
            </a:r>
            <a:r>
              <a:rPr lang="en-US" dirty="0"/>
              <a:t>Ccne1</a:t>
            </a:r>
            <a:r>
              <a:rPr lang="en-US" baseline="30000" dirty="0"/>
              <a:t>OE </a:t>
            </a:r>
            <a:r>
              <a:rPr lang="en-US" dirty="0"/>
              <a:t>sarcoma cells expressing WT (</a:t>
            </a:r>
            <a:r>
              <a:rPr lang="en-US" dirty="0" err="1"/>
              <a:t>Postn</a:t>
            </a:r>
            <a:r>
              <a:rPr lang="en-US" dirty="0"/>
              <a:t>-WT) or over-expressed </a:t>
            </a:r>
            <a:r>
              <a:rPr lang="en-US" dirty="0" err="1"/>
              <a:t>Postn</a:t>
            </a:r>
            <a:r>
              <a:rPr lang="en-US" dirty="0"/>
              <a:t> levels (</a:t>
            </a:r>
            <a:r>
              <a:rPr lang="en-US" dirty="0" err="1"/>
              <a:t>Postn</a:t>
            </a:r>
            <a:r>
              <a:rPr lang="en-US" dirty="0"/>
              <a:t>-OE). (</a:t>
            </a:r>
            <a:r>
              <a:rPr lang="en-US" b="1" dirty="0"/>
              <a:t>D</a:t>
            </a:r>
            <a:r>
              <a:rPr lang="en-US" dirty="0"/>
              <a:t>) Flow cytometry analysis of different types of immune cells within the CD45+ population in the microenvironment of </a:t>
            </a:r>
            <a:r>
              <a:rPr lang="en-US" dirty="0" err="1"/>
              <a:t>Postn</a:t>
            </a:r>
            <a:r>
              <a:rPr lang="en-US" dirty="0"/>
              <a:t>-WT and </a:t>
            </a:r>
            <a:r>
              <a:rPr lang="en-US" dirty="0" err="1"/>
              <a:t>Postn</a:t>
            </a:r>
            <a:r>
              <a:rPr lang="en-US" dirty="0"/>
              <a:t>-over-expressed (</a:t>
            </a:r>
            <a:r>
              <a:rPr lang="en-US" dirty="0" err="1"/>
              <a:t>Postn</a:t>
            </a:r>
            <a:r>
              <a:rPr lang="en-US" dirty="0"/>
              <a:t>-OE) tumors (p53</a:t>
            </a:r>
            <a:r>
              <a:rPr lang="en-US" baseline="30000" dirty="0"/>
              <a:t>KO</a:t>
            </a:r>
            <a:r>
              <a:rPr lang="en-US" dirty="0"/>
              <a:t>Ccne1</a:t>
            </a:r>
            <a:r>
              <a:rPr lang="en-US" baseline="30000" dirty="0"/>
              <a:t>OE</a:t>
            </a:r>
            <a:r>
              <a:rPr lang="en-US" dirty="0"/>
              <a:t>). Each dot represents one mouse. (</a:t>
            </a:r>
            <a:r>
              <a:rPr lang="en-US" b="1" dirty="0"/>
              <a:t>E</a:t>
            </a:r>
            <a:r>
              <a:rPr lang="en-US" dirty="0"/>
              <a:t>) Tumors weight upon treatment with anti-</a:t>
            </a:r>
            <a:r>
              <a:rPr lang="en-US" dirty="0" err="1"/>
              <a:t>Postn</a:t>
            </a:r>
            <a:r>
              <a:rPr lang="en-US" dirty="0"/>
              <a:t> antibody. </a:t>
            </a:r>
          </a:p>
        </p:txBody>
      </p:sp>
    </p:spTree>
    <p:extLst>
      <p:ext uri="{BB962C8B-B14F-4D97-AF65-F5344CB8AC3E}">
        <p14:creationId xmlns:p14="http://schemas.microsoft.com/office/powerpoint/2010/main" val="2129089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9</TotalTime>
  <Words>131</Words>
  <Application>Microsoft Macintosh PowerPoint</Application>
  <PresentationFormat>Letter Paper (8.5x11 in)</PresentationFormat>
  <Paragraphs>8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arnerio, Jlenia</dc:creator>
  <cp:lastModifiedBy>Guarnerio,Jlenia</cp:lastModifiedBy>
  <cp:revision>1</cp:revision>
  <dcterms:created xsi:type="dcterms:W3CDTF">2021-05-16T05:20:50Z</dcterms:created>
  <dcterms:modified xsi:type="dcterms:W3CDTF">2025-11-07T15:16:31Z</dcterms:modified>
</cp:coreProperties>
</file>